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735763" cy="98663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61" autoAdjust="0"/>
    <p:restoredTop sz="94660"/>
  </p:normalViewPr>
  <p:slideViewPr>
    <p:cSldViewPr>
      <p:cViewPr varScale="1">
        <p:scale>
          <a:sx n="69" d="100"/>
          <a:sy n="69" d="100"/>
        </p:scale>
        <p:origin x="-132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r">
              <a:defRPr sz="1200"/>
            </a:lvl1pPr>
          </a:lstStyle>
          <a:p>
            <a:fld id="{24B17DEB-0904-4369-A6EA-ACB00E3A52A9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5" tIns="45713" rIns="91425" bIns="45713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25" tIns="45713" rIns="91425" bIns="45713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15374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r">
              <a:defRPr sz="1200"/>
            </a:lvl1pPr>
          </a:lstStyle>
          <a:p>
            <a:fld id="{27C71963-4059-4562-914A-FF42F7120A56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>
          <a:xfrm>
            <a:off x="901700" y="739775"/>
            <a:ext cx="4932363" cy="3700463"/>
          </a:xfrm>
        </p:spPr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C71963-4059-4562-914A-FF42F7120A56}" type="slidenum">
              <a:rPr lang="ru-RU" smtClean="0"/>
              <a:pPr/>
              <a:t>1</a:t>
            </a:fld>
            <a:endParaRPr lang="ru-R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Прямоугольник 1"/>
          <p:cNvSpPr/>
          <p:nvPr/>
        </p:nvSpPr>
        <p:spPr>
          <a:xfrm>
            <a:off x="467544" y="836713"/>
            <a:ext cx="8424936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/>
              <a:t>…..TGGAGAGAAAGGGCTGTCAGGTGGCCGCGGCGGCCGGCGTGCGAGGGACCGGATGCCCAAGCCGGG</a:t>
            </a:r>
          </a:p>
          <a:p>
            <a:endParaRPr lang="en-US" sz="1600" b="1" dirty="0" smtClean="0"/>
          </a:p>
          <a:p>
            <a:endParaRPr lang="en-US" sz="1600" b="1" dirty="0" smtClean="0"/>
          </a:p>
          <a:p>
            <a:r>
              <a:rPr lang="en-US" sz="1600" b="1" dirty="0" smtClean="0"/>
              <a:t>CGGATTTGGAAAAGGATAGCTGGTAATCGTGGCTTGTTTTGCTTTGTTTTCTTTTCCAG </a:t>
            </a:r>
            <a:r>
              <a:rPr lang="en-US" sz="16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CAACGAAGGTTTT</a:t>
            </a:r>
          </a:p>
          <a:p>
            <a:endParaRPr lang="en-US" sz="1600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endParaRPr lang="en-US" sz="1600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US" sz="16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GGGAACAGTAAAATGGTTCAATGTAAGGAA….</a:t>
            </a:r>
          </a:p>
          <a:p>
            <a:endParaRPr lang="ru-RU" sz="16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23528" y="5949280"/>
            <a:ext cx="83529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2</a:t>
            </a:r>
            <a:r>
              <a:rPr lang="ru-RU" sz="11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ru-RU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Nucleotide sequence of a fragment of alternative 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YB-1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from human MCF7 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 and HEK293 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 cells. The sequenced chains are identical.</a:t>
            </a:r>
            <a:endParaRPr lang="ru-RU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41995" y="42904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sz="1600" b="1" dirty="0" smtClean="0">
                <a:latin typeface="Arial" pitchFamily="34" charset="0"/>
                <a:cs typeface="Arial" pitchFamily="34" charset="0"/>
              </a:rPr>
              <a:t>А</a:t>
            </a:r>
            <a:endParaRPr lang="ru-RU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1520" y="321297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ru-RU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Прямая соединительная линия 5"/>
          <p:cNvCxnSpPr/>
          <p:nvPr/>
        </p:nvCxnSpPr>
        <p:spPr>
          <a:xfrm flipV="1">
            <a:off x="7173815" y="1423991"/>
            <a:ext cx="0" cy="468000"/>
          </a:xfrm>
          <a:prstGeom prst="line">
            <a:avLst/>
          </a:prstGeom>
          <a:ln>
            <a:solidFill>
              <a:schemeClr val="tx1"/>
            </a:solidFill>
            <a:tailEnd type="non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7183340" y="1403251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ex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2</a:t>
            </a:r>
            <a:endParaRPr lang="ru-RU" sz="10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478112" y="1403251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intr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1</a:t>
            </a:r>
            <a:endParaRPr lang="ru-RU" sz="10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Прямоугольник 9"/>
          <p:cNvSpPr/>
          <p:nvPr/>
        </p:nvSpPr>
        <p:spPr>
          <a:xfrm>
            <a:off x="463352" y="3577938"/>
            <a:ext cx="8424936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/>
              <a:t>…..TGGAGAGAAAGGGCTGTCAGGTGGCCGCGGCGGCCGGCGTGCGAGGGACCGGATGCCCAAGCCGGG</a:t>
            </a:r>
          </a:p>
          <a:p>
            <a:endParaRPr lang="en-US" sz="1600" b="1" dirty="0" smtClean="0"/>
          </a:p>
          <a:p>
            <a:endParaRPr lang="en-US" sz="1600" b="1" dirty="0" smtClean="0"/>
          </a:p>
          <a:p>
            <a:r>
              <a:rPr lang="en-US" sz="1600" b="1" dirty="0" smtClean="0"/>
              <a:t>CGGATTTGGAAAAGGATAGCTGGTAATCGTGGCTTGTTTTGCTTTGTTTTCTTTTCCAG </a:t>
            </a:r>
            <a:r>
              <a:rPr lang="en-US" sz="16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CAACGAAGGTTTT</a:t>
            </a:r>
          </a:p>
          <a:p>
            <a:endParaRPr lang="en-US" sz="1600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endParaRPr lang="en-US" sz="1600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US" sz="16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GGGAACAGTAAAATGGTTCAATGTAAGGAA….</a:t>
            </a:r>
          </a:p>
          <a:p>
            <a:endParaRPr lang="ru-RU" sz="16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cxnSp>
        <p:nvCxnSpPr>
          <p:cNvPr id="11" name="Прямая соединительная линия 10"/>
          <p:cNvCxnSpPr/>
          <p:nvPr/>
        </p:nvCxnSpPr>
        <p:spPr>
          <a:xfrm flipV="1">
            <a:off x="7169623" y="4165216"/>
            <a:ext cx="0" cy="468000"/>
          </a:xfrm>
          <a:prstGeom prst="line">
            <a:avLst/>
          </a:prstGeom>
          <a:ln>
            <a:solidFill>
              <a:schemeClr val="tx1"/>
            </a:solidFill>
            <a:tailEnd type="non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179148" y="4144475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ex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2</a:t>
            </a:r>
            <a:endParaRPr lang="ru-RU" sz="10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73920" y="4144475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intr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1</a:t>
            </a:r>
            <a:endParaRPr lang="ru-RU" sz="10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2</TotalTime>
  <Words>55</Words>
  <Application>Microsoft Office PowerPoint</Application>
  <PresentationFormat>Экран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Lyabin</dc:creator>
  <cp:lastModifiedBy>Admin</cp:lastModifiedBy>
  <cp:revision>125</cp:revision>
  <dcterms:created xsi:type="dcterms:W3CDTF">2012-07-09T09:21:16Z</dcterms:created>
  <dcterms:modified xsi:type="dcterms:W3CDTF">2014-07-17T09:13:22Z</dcterms:modified>
</cp:coreProperties>
</file>